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2" d="100"/>
          <a:sy n="102" d="100"/>
        </p:scale>
        <p:origin x="-1410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9BF2D-2588-431F-B3C6-2E80C1392245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BE190-7BC0-4953-B7D2-431F6E0AF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014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9BF2D-2588-431F-B3C6-2E80C1392245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BE190-7BC0-4953-B7D2-431F6E0AF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85012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9BF2D-2588-431F-B3C6-2E80C1392245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BE190-7BC0-4953-B7D2-431F6E0AF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610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9BF2D-2588-431F-B3C6-2E80C1392245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BE190-7BC0-4953-B7D2-431F6E0AF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8551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9BF2D-2588-431F-B3C6-2E80C1392245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BE190-7BC0-4953-B7D2-431F6E0AF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323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9BF2D-2588-431F-B3C6-2E80C1392245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BE190-7BC0-4953-B7D2-431F6E0AF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1050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9BF2D-2588-431F-B3C6-2E80C1392245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BE190-7BC0-4953-B7D2-431F6E0AF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09292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9BF2D-2588-431F-B3C6-2E80C1392245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BE190-7BC0-4953-B7D2-431F6E0AF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3886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9BF2D-2588-431F-B3C6-2E80C1392245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BE190-7BC0-4953-B7D2-431F6E0AF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0657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9BF2D-2588-431F-B3C6-2E80C1392245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BE190-7BC0-4953-B7D2-431F6E0AF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17011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9BF2D-2588-431F-B3C6-2E80C1392245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BE190-7BC0-4953-B7D2-431F6E0AF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72892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49BF2D-2588-431F-B3C6-2E80C1392245}" type="datetimeFigureOut">
              <a:rPr lang="en-US" smtClean="0"/>
              <a:t>12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2BE190-7BC0-4953-B7D2-431F6E0AF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0682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602635"/>
            <a:ext cx="7704856" cy="3952205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TextBox 6"/>
          <p:cNvSpPr txBox="1"/>
          <p:nvPr/>
        </p:nvSpPr>
        <p:spPr>
          <a:xfrm>
            <a:off x="611560" y="5085184"/>
            <a:ext cx="74168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b="1" dirty="0"/>
              <a:t>Figure S2.</a:t>
            </a:r>
            <a:r>
              <a:rPr lang="en-AU" sz="1000" dirty="0"/>
              <a:t> UTR regions with expression pattern not correlated with the expression pattern of the adjacent gene upon changed oxygen levels (spearman correlation, </a:t>
            </a:r>
            <a:r>
              <a:rPr lang="en-AU" sz="1000" i="1" dirty="0" err="1"/>
              <a:t>r</a:t>
            </a:r>
            <a:r>
              <a:rPr lang="en-AU" sz="1000" i="1" baseline="-25000" dirty="0" err="1"/>
              <a:t>s</a:t>
            </a:r>
            <a:r>
              <a:rPr lang="en-AU" sz="1000" dirty="0"/>
              <a:t> &lt; 0.6).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17674955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0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Sydne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guel Hernandez</dc:creator>
  <cp:lastModifiedBy>Miguel Hernandez</cp:lastModifiedBy>
  <cp:revision>1</cp:revision>
  <dcterms:created xsi:type="dcterms:W3CDTF">2016-12-07T23:47:44Z</dcterms:created>
  <dcterms:modified xsi:type="dcterms:W3CDTF">2016-12-07T23:52:23Z</dcterms:modified>
</cp:coreProperties>
</file>